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7" r:id="rId2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40" autoAdjust="0"/>
    <p:restoredTop sz="94633"/>
  </p:normalViewPr>
  <p:slideViewPr>
    <p:cSldViewPr snapToGrid="0" snapToObjects="1">
      <p:cViewPr varScale="1">
        <p:scale>
          <a:sx n="80" d="100"/>
          <a:sy n="80" d="100"/>
        </p:scale>
        <p:origin x="29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ro\Dropbox\SM\&#23455;&#39443;\2020\&#65303;\200720RNAseq_graph%20to%20validate%20realtimePC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ro\Dropbox\SM\&#23455;&#39443;\2020\&#65303;\200720RNAseq_graph%20to%20validate%20realtimePC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ro\Dropbox\SM\&#23455;&#39443;\2020\&#65303;\200720RNAseq_graph%20to%20validate%20realtimePCR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ro\Dropbox\SM\&#23455;&#39443;\2020\&#65303;\200720RNAseq_graph%20to%20validate%20realtimePCR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ro\Dropbox\SM\&#23455;&#39443;\2020\&#65303;\200720RNAseq_graph%20to%20validate%20realtimePCR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iro\Dropbox\SM\&#23455;&#39443;\2020\&#65303;\200720RNAseq_graph%20to%20validate%20realtimePCR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1;1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74:$F$74</c:f>
                <c:numCache>
                  <c:formatCode>General</c:formatCode>
                  <c:ptCount val="2"/>
                  <c:pt idx="0">
                    <c:v>3.0421492796972515E-3</c:v>
                  </c:pt>
                  <c:pt idx="1">
                    <c:v>1.9905811692252594E-2</c:v>
                  </c:pt>
                </c:numCache>
              </c:numRef>
            </c:plus>
            <c:minus>
              <c:numRef>
                <c:f>log2じゃない方!$E$74:$F$74</c:f>
                <c:numCache>
                  <c:formatCode>General</c:formatCode>
                  <c:ptCount val="2"/>
                  <c:pt idx="0">
                    <c:v>3.0421492796972515E-3</c:v>
                  </c:pt>
                  <c:pt idx="1">
                    <c:v>1.990581169225259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2"/>
              <c:pt idx="0">
                <c:v>Central</c:v>
              </c:pt>
              <c:pt idx="1">
                <c:v>Peripheral</c:v>
              </c:pt>
            </c:strLit>
          </c:cat>
          <c:val>
            <c:numRef>
              <c:f>log2じゃない方!$C$74:$D$74</c:f>
              <c:numCache>
                <c:formatCode>General</c:formatCode>
                <c:ptCount val="2"/>
                <c:pt idx="0">
                  <c:v>2.2025919499727181E-2</c:v>
                </c:pt>
                <c:pt idx="1">
                  <c:v>5.725740292142720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6B-471D-A30D-498CF001FC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>
                <a:alpha val="97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5786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NHX3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83:$F$83</c:f>
                <c:numCache>
                  <c:formatCode>General</c:formatCode>
                  <c:ptCount val="2"/>
                  <c:pt idx="0">
                    <c:v>0.33322472176684842</c:v>
                  </c:pt>
                  <c:pt idx="1">
                    <c:v>3.9702642419850699E-2</c:v>
                  </c:pt>
                </c:numCache>
              </c:numRef>
            </c:plus>
            <c:minus>
              <c:numRef>
                <c:f>log2じゃない方!$E$83:$F$83</c:f>
                <c:numCache>
                  <c:formatCode>General</c:formatCode>
                  <c:ptCount val="2"/>
                  <c:pt idx="0">
                    <c:v>0.33322472176684842</c:v>
                  </c:pt>
                  <c:pt idx="1">
                    <c:v>3.97026424198506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83:$D$83</c:f>
              <c:numCache>
                <c:formatCode>General</c:formatCode>
                <c:ptCount val="2"/>
                <c:pt idx="0">
                  <c:v>2.1906143651347727</c:v>
                </c:pt>
                <c:pt idx="1">
                  <c:v>1.3627394845731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4F7-4074-B083-740775D3EF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NHX4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84:$F$84</c:f>
                <c:numCache>
                  <c:formatCode>General</c:formatCode>
                  <c:ptCount val="2"/>
                  <c:pt idx="0">
                    <c:v>3.109982923661399E-3</c:v>
                  </c:pt>
                  <c:pt idx="1">
                    <c:v>1.3371612682824201E-3</c:v>
                  </c:pt>
                </c:numCache>
              </c:numRef>
            </c:plus>
            <c:minus>
              <c:numRef>
                <c:f>log2じゃない方!$E$84:$F$84</c:f>
                <c:numCache>
                  <c:formatCode>General</c:formatCode>
                  <c:ptCount val="2"/>
                  <c:pt idx="0">
                    <c:v>3.109982923661399E-3</c:v>
                  </c:pt>
                  <c:pt idx="1">
                    <c:v>1.337161268282420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84:$D$84</c:f>
              <c:numCache>
                <c:formatCode>General</c:formatCode>
                <c:ptCount val="2"/>
                <c:pt idx="0">
                  <c:v>1.9406753995862027E-2</c:v>
                </c:pt>
                <c:pt idx="1">
                  <c:v>2.50582139793031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DC-4F09-974B-42D0249687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NHX5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2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85:$F$85</c:f>
                <c:numCache>
                  <c:formatCode>General</c:formatCode>
                  <c:ptCount val="2"/>
                  <c:pt idx="0">
                    <c:v>0.12324838905916276</c:v>
                  </c:pt>
                  <c:pt idx="1">
                    <c:v>3.9431804908455895E-2</c:v>
                  </c:pt>
                </c:numCache>
              </c:numRef>
            </c:plus>
            <c:minus>
              <c:numRef>
                <c:f>log2じゃない方!$E$85:$F$85</c:f>
                <c:numCache>
                  <c:formatCode>General</c:formatCode>
                  <c:ptCount val="2"/>
                  <c:pt idx="0">
                    <c:v>0.12324838905916276</c:v>
                  </c:pt>
                  <c:pt idx="1">
                    <c:v>3.943180490845589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85:$D$85</c:f>
              <c:numCache>
                <c:formatCode>General</c:formatCode>
                <c:ptCount val="2"/>
                <c:pt idx="0">
                  <c:v>0.74202670926338266</c:v>
                </c:pt>
                <c:pt idx="1">
                  <c:v>1.06035777635947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1B5-42AA-BF33-7D6E9C4CE0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SOS1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86:$F$86</c:f>
                <c:numCache>
                  <c:formatCode>General</c:formatCode>
                  <c:ptCount val="2"/>
                  <c:pt idx="0">
                    <c:v>0.13206198154732726</c:v>
                  </c:pt>
                  <c:pt idx="1">
                    <c:v>4.5645697411082542E-2</c:v>
                  </c:pt>
                </c:numCache>
              </c:numRef>
            </c:plus>
            <c:minus>
              <c:numRef>
                <c:f>log2じゃない方!$E$86:$F$86</c:f>
                <c:numCache>
                  <c:formatCode>General</c:formatCode>
                  <c:ptCount val="2"/>
                  <c:pt idx="0">
                    <c:v>0.13206198154732726</c:v>
                  </c:pt>
                  <c:pt idx="1">
                    <c:v>4.564569741108254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86:$D$86</c:f>
              <c:numCache>
                <c:formatCode>General</c:formatCode>
                <c:ptCount val="2"/>
                <c:pt idx="0">
                  <c:v>0.69913409631757839</c:v>
                </c:pt>
                <c:pt idx="1">
                  <c:v>0.723779165832487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5BC-4ED7-8FAB-0AA539D267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1;3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75:$F$75</c:f>
                <c:numCache>
                  <c:formatCode>General</c:formatCode>
                  <c:ptCount val="2"/>
                  <c:pt idx="0">
                    <c:v>7.3784203936437427E-3</c:v>
                  </c:pt>
                  <c:pt idx="1">
                    <c:v>5.5831203421030746E-3</c:v>
                  </c:pt>
                </c:numCache>
              </c:numRef>
            </c:plus>
            <c:minus>
              <c:numRef>
                <c:f>log2じゃない方!$E$75:$F$75</c:f>
                <c:numCache>
                  <c:formatCode>General</c:formatCode>
                  <c:ptCount val="2"/>
                  <c:pt idx="0">
                    <c:v>7.3784203936437427E-3</c:v>
                  </c:pt>
                  <c:pt idx="1">
                    <c:v>5.583120342103074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75:$D$75</c:f>
              <c:numCache>
                <c:formatCode>General</c:formatCode>
                <c:ptCount val="2"/>
                <c:pt idx="0">
                  <c:v>2.6149022257825682E-2</c:v>
                </c:pt>
                <c:pt idx="1">
                  <c:v>8.412789114468294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43-49E0-847B-4FB09BDF93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5786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1;4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76:$F$76</c:f>
                <c:numCache>
                  <c:formatCode>General</c:formatCode>
                  <c:ptCount val="2"/>
                  <c:pt idx="0">
                    <c:v>5.2666888671381244E-2</c:v>
                  </c:pt>
                  <c:pt idx="1">
                    <c:v>3.0762130066784156E-3</c:v>
                  </c:pt>
                </c:numCache>
              </c:numRef>
            </c:plus>
            <c:minus>
              <c:numRef>
                <c:f>log2じゃない方!$E$76:$F$76</c:f>
                <c:numCache>
                  <c:formatCode>General</c:formatCode>
                  <c:ptCount val="2"/>
                  <c:pt idx="0">
                    <c:v>5.2666888671381244E-2</c:v>
                  </c:pt>
                  <c:pt idx="1">
                    <c:v>3.076213006678415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76:$D$76</c:f>
              <c:numCache>
                <c:formatCode>General</c:formatCode>
                <c:ptCount val="2"/>
                <c:pt idx="0">
                  <c:v>0.16476397243991672</c:v>
                </c:pt>
                <c:pt idx="1">
                  <c:v>4.467589149807375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870-499D-8D52-DD3F728536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5786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1;5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77:$F$77</c:f>
                <c:numCache>
                  <c:formatCode>General</c:formatCode>
                  <c:ptCount val="2"/>
                  <c:pt idx="0">
                    <c:v>4.8253325621548581E-3</c:v>
                  </c:pt>
                  <c:pt idx="1">
                    <c:v>4.8058101604152567E-2</c:v>
                  </c:pt>
                </c:numCache>
              </c:numRef>
            </c:plus>
            <c:minus>
              <c:numRef>
                <c:f>log2じゃない方!$E$77:$F$77</c:f>
                <c:numCache>
                  <c:formatCode>General</c:formatCode>
                  <c:ptCount val="2"/>
                  <c:pt idx="0">
                    <c:v>4.8253325621548581E-3</c:v>
                  </c:pt>
                  <c:pt idx="1">
                    <c:v>4.805810160415256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77:$D$77</c:f>
              <c:numCache>
                <c:formatCode>General</c:formatCode>
                <c:ptCount val="2"/>
                <c:pt idx="0">
                  <c:v>3.6904292889209593E-2</c:v>
                </c:pt>
                <c:pt idx="1">
                  <c:v>0.119667048317085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F6-46AD-8620-B25A583A99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5786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2;1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78:$F$78</c:f>
                <c:numCache>
                  <c:formatCode>General</c:formatCode>
                  <c:ptCount val="2"/>
                  <c:pt idx="0">
                    <c:v>1.32553502649356E-2</c:v>
                  </c:pt>
                  <c:pt idx="1">
                    <c:v>1.3427033787556987E-3</c:v>
                  </c:pt>
                </c:numCache>
              </c:numRef>
            </c:plus>
            <c:minus>
              <c:numRef>
                <c:f>log2じゃない方!$E$78:$F$78</c:f>
                <c:numCache>
                  <c:formatCode>General</c:formatCode>
                  <c:ptCount val="2"/>
                  <c:pt idx="0">
                    <c:v>1.32553502649356E-2</c:v>
                  </c:pt>
                  <c:pt idx="1">
                    <c:v>1.342703378755698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78:$D$78</c:f>
              <c:numCache>
                <c:formatCode>General</c:formatCode>
                <c:ptCount val="2"/>
                <c:pt idx="0">
                  <c:v>7.0746876535936379E-2</c:v>
                </c:pt>
                <c:pt idx="1">
                  <c:v>2.497632533806487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C23-41F1-AAF2-368B451767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5786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2;3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79:$F$79</c:f>
                <c:numCache>
                  <c:formatCode>General</c:formatCode>
                  <c:ptCount val="2"/>
                  <c:pt idx="0">
                    <c:v>4.7882367272769361E-3</c:v>
                  </c:pt>
                  <c:pt idx="1">
                    <c:v>3.7865544852805279E-2</c:v>
                  </c:pt>
                </c:numCache>
              </c:numRef>
            </c:plus>
            <c:minus>
              <c:numRef>
                <c:f>log2じゃない方!$E$79:$F$79</c:f>
                <c:numCache>
                  <c:formatCode>General</c:formatCode>
                  <c:ptCount val="2"/>
                  <c:pt idx="0">
                    <c:v>4.7882367272769361E-3</c:v>
                  </c:pt>
                  <c:pt idx="1">
                    <c:v>3.786554485280527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79:$D$79</c:f>
              <c:numCache>
                <c:formatCode>General</c:formatCode>
                <c:ptCount val="2"/>
                <c:pt idx="0">
                  <c:v>2.4298062322210157E-2</c:v>
                </c:pt>
                <c:pt idx="1">
                  <c:v>0.168578943128538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25-46F8-BD2E-8A05A7504A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5786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HKT2;4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80:$F$80</c:f>
                <c:numCache>
                  <c:formatCode>General</c:formatCode>
                  <c:ptCount val="2"/>
                  <c:pt idx="0">
                    <c:v>3.2878448892398587E-3</c:v>
                  </c:pt>
                  <c:pt idx="1">
                    <c:v>4.9826327657025431E-2</c:v>
                  </c:pt>
                </c:numCache>
              </c:numRef>
            </c:plus>
            <c:minus>
              <c:numRef>
                <c:f>log2じゃない方!$E$80:$F$80</c:f>
                <c:numCache>
                  <c:formatCode>General</c:formatCode>
                  <c:ptCount val="2"/>
                  <c:pt idx="0">
                    <c:v>3.2878448892398587E-3</c:v>
                  </c:pt>
                  <c:pt idx="1">
                    <c:v>4.9826327657025431E-2</c:v>
                  </c:pt>
                </c:numCache>
              </c:numRef>
            </c:minus>
          </c:errBars>
          <c:val>
            <c:numRef>
              <c:f>log2じゃない方!$C$80:$D$80</c:f>
              <c:numCache>
                <c:formatCode>General</c:formatCode>
                <c:ptCount val="2"/>
                <c:pt idx="0">
                  <c:v>2.0854895981413227E-2</c:v>
                </c:pt>
                <c:pt idx="1">
                  <c:v>0.190557123792204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3F1-4AD3-BB91-E9326F0379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NHX1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2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81:$F$81</c:f>
                <c:numCache>
                  <c:formatCode>General</c:formatCode>
                  <c:ptCount val="2"/>
                  <c:pt idx="0">
                    <c:v>0.23864251839641637</c:v>
                  </c:pt>
                  <c:pt idx="1">
                    <c:v>0.12849363104753991</c:v>
                  </c:pt>
                </c:numCache>
              </c:numRef>
            </c:plus>
            <c:minus>
              <c:numRef>
                <c:f>log2じゃない方!$E$81:$F$81</c:f>
                <c:numCache>
                  <c:formatCode>General</c:formatCode>
                  <c:ptCount val="2"/>
                  <c:pt idx="0">
                    <c:v>0.23864251839641637</c:v>
                  </c:pt>
                  <c:pt idx="1">
                    <c:v>0.128493631047539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81:$D$81</c:f>
              <c:numCache>
                <c:formatCode>General</c:formatCode>
                <c:ptCount val="2"/>
                <c:pt idx="0">
                  <c:v>1.0189627314819691</c:v>
                </c:pt>
                <c:pt idx="1">
                  <c:v>0.594391411426170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3A9-4C73-94B9-2B8C46EED6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NHX2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3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82:$F$82</c:f>
                <c:numCache>
                  <c:formatCode>General</c:formatCode>
                  <c:ptCount val="2"/>
                  <c:pt idx="0">
                    <c:v>0.1924207766301311</c:v>
                  </c:pt>
                  <c:pt idx="1">
                    <c:v>4.0968724462574949E-2</c:v>
                  </c:pt>
                </c:numCache>
              </c:numRef>
            </c:plus>
            <c:minus>
              <c:numRef>
                <c:f>log2じゃない方!$E$82:$F$82</c:f>
                <c:numCache>
                  <c:formatCode>General</c:formatCode>
                  <c:ptCount val="2"/>
                  <c:pt idx="0">
                    <c:v>0.1924207766301311</c:v>
                  </c:pt>
                  <c:pt idx="1">
                    <c:v>4.096872446257494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82:$D$82</c:f>
              <c:numCache>
                <c:formatCode>General</c:formatCode>
                <c:ptCount val="2"/>
                <c:pt idx="0">
                  <c:v>1.3227410298551119</c:v>
                </c:pt>
                <c:pt idx="1">
                  <c:v>1.96472214246752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154-403A-8C85-476A2A65A3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799801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5546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911431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81428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957725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223528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949537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8650046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163792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537358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18676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657373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E0E8D466-2426-4A86-80B2-24B9D0BFC16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2474859"/>
              </p:ext>
            </p:extLst>
          </p:nvPr>
        </p:nvGraphicFramePr>
        <p:xfrm>
          <a:off x="634549" y="759995"/>
          <a:ext cx="1938893" cy="14195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0323074E-FFEA-4DD5-8BC8-F31D5D0B6AE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0211760"/>
              </p:ext>
            </p:extLst>
          </p:nvPr>
        </p:nvGraphicFramePr>
        <p:xfrm>
          <a:off x="2619073" y="759995"/>
          <a:ext cx="1934496" cy="14195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6BB5FF7C-5E01-42F8-ACD7-99ED33CDE3B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2265009"/>
              </p:ext>
            </p:extLst>
          </p:nvPr>
        </p:nvGraphicFramePr>
        <p:xfrm>
          <a:off x="4598117" y="759995"/>
          <a:ext cx="1930977" cy="14195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0" name="グラフ 19">
            <a:extLst>
              <a:ext uri="{FF2B5EF4-FFF2-40B4-BE49-F238E27FC236}">
                <a16:creationId xmlns:a16="http://schemas.microsoft.com/office/drawing/2014/main" id="{F8BF81DC-3CDD-4D98-9813-D392627BFD4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565166"/>
              </p:ext>
            </p:extLst>
          </p:nvPr>
        </p:nvGraphicFramePr>
        <p:xfrm>
          <a:off x="634549" y="2239329"/>
          <a:ext cx="1938893" cy="14247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1" name="グラフ 20">
            <a:extLst>
              <a:ext uri="{FF2B5EF4-FFF2-40B4-BE49-F238E27FC236}">
                <a16:creationId xmlns:a16="http://schemas.microsoft.com/office/drawing/2014/main" id="{9C146E87-4208-4FD6-A053-16B03FFE4C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5272194"/>
              </p:ext>
            </p:extLst>
          </p:nvPr>
        </p:nvGraphicFramePr>
        <p:xfrm>
          <a:off x="2619073" y="2243020"/>
          <a:ext cx="1934496" cy="14195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A3D76732-ED08-4D28-AE68-27547EAF84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7033610"/>
              </p:ext>
            </p:extLst>
          </p:nvPr>
        </p:nvGraphicFramePr>
        <p:xfrm>
          <a:off x="4598117" y="2236055"/>
          <a:ext cx="1930977" cy="14195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268CFFCD-FE76-4367-B92A-C1EF65BB102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035672"/>
              </p:ext>
            </p:extLst>
          </p:nvPr>
        </p:nvGraphicFramePr>
        <p:xfrm>
          <a:off x="634549" y="3708671"/>
          <a:ext cx="1938893" cy="14247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4" name="グラフ 23">
            <a:extLst>
              <a:ext uri="{FF2B5EF4-FFF2-40B4-BE49-F238E27FC236}">
                <a16:creationId xmlns:a16="http://schemas.microsoft.com/office/drawing/2014/main" id="{EF4B6DD2-5725-4DE8-8879-99894D75359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4704504"/>
              </p:ext>
            </p:extLst>
          </p:nvPr>
        </p:nvGraphicFramePr>
        <p:xfrm>
          <a:off x="2619074" y="3711297"/>
          <a:ext cx="1934496" cy="14195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5" name="グラフ 24">
            <a:extLst>
              <a:ext uri="{FF2B5EF4-FFF2-40B4-BE49-F238E27FC236}">
                <a16:creationId xmlns:a16="http://schemas.microsoft.com/office/drawing/2014/main" id="{59581B6A-C741-48B9-8F1D-67DBB1B74B0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0719540"/>
              </p:ext>
            </p:extLst>
          </p:nvPr>
        </p:nvGraphicFramePr>
        <p:xfrm>
          <a:off x="4596357" y="3711297"/>
          <a:ext cx="1934495" cy="14195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B9FDC4F2-299F-4CAC-A82A-54998B022D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1719155"/>
              </p:ext>
            </p:extLst>
          </p:nvPr>
        </p:nvGraphicFramePr>
        <p:xfrm>
          <a:off x="634549" y="5192760"/>
          <a:ext cx="1938893" cy="14195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27" name="グラフ 26">
            <a:extLst>
              <a:ext uri="{FF2B5EF4-FFF2-40B4-BE49-F238E27FC236}">
                <a16:creationId xmlns:a16="http://schemas.microsoft.com/office/drawing/2014/main" id="{B34A82A5-40FE-4D18-B993-56B8D5F0CC6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6703758"/>
              </p:ext>
            </p:extLst>
          </p:nvPr>
        </p:nvGraphicFramePr>
        <p:xfrm>
          <a:off x="2619074" y="5194323"/>
          <a:ext cx="1934496" cy="14247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28" name="グラフ 27">
            <a:extLst>
              <a:ext uri="{FF2B5EF4-FFF2-40B4-BE49-F238E27FC236}">
                <a16:creationId xmlns:a16="http://schemas.microsoft.com/office/drawing/2014/main" id="{BBCAF657-B0C6-4E72-90A6-5C88408EAB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3116740"/>
              </p:ext>
            </p:extLst>
          </p:nvPr>
        </p:nvGraphicFramePr>
        <p:xfrm>
          <a:off x="4596357" y="5186539"/>
          <a:ext cx="1930977" cy="14195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29" name="グラフ 28">
            <a:extLst>
              <a:ext uri="{FF2B5EF4-FFF2-40B4-BE49-F238E27FC236}">
                <a16:creationId xmlns:a16="http://schemas.microsoft.com/office/drawing/2014/main" id="{12104002-5343-411A-BFBD-7DF838B66C2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3626482"/>
              </p:ext>
            </p:extLst>
          </p:nvPr>
        </p:nvGraphicFramePr>
        <p:xfrm>
          <a:off x="634549" y="6672095"/>
          <a:ext cx="1938893" cy="14195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EFBC5D5-FB4E-4EDD-B391-1B881B521EAC}"/>
              </a:ext>
            </a:extLst>
          </p:cNvPr>
          <p:cNvSpPr txBox="1"/>
          <p:nvPr/>
        </p:nvSpPr>
        <p:spPr>
          <a:xfrm>
            <a:off x="3934752" y="1071609"/>
            <a:ext cx="2776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AC25935-C147-43FF-BAD3-AB8F44772975}"/>
              </a:ext>
            </a:extLst>
          </p:cNvPr>
          <p:cNvSpPr txBox="1"/>
          <p:nvPr/>
        </p:nvSpPr>
        <p:spPr>
          <a:xfrm>
            <a:off x="3238703" y="2594338"/>
            <a:ext cx="2776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5E08D35-8C4C-4A72-8A4F-4D68E890183E}"/>
              </a:ext>
            </a:extLst>
          </p:cNvPr>
          <p:cNvSpPr txBox="1"/>
          <p:nvPr/>
        </p:nvSpPr>
        <p:spPr>
          <a:xfrm>
            <a:off x="5892775" y="2679135"/>
            <a:ext cx="2776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39F07C16-ED46-4954-AF9C-D72EC5152BDE}"/>
              </a:ext>
            </a:extLst>
          </p:cNvPr>
          <p:cNvSpPr txBox="1"/>
          <p:nvPr/>
        </p:nvSpPr>
        <p:spPr>
          <a:xfrm>
            <a:off x="1938853" y="4084016"/>
            <a:ext cx="2776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E0FC4297-6981-4B36-83D0-E19FEA12FF44}"/>
              </a:ext>
            </a:extLst>
          </p:cNvPr>
          <p:cNvSpPr txBox="1"/>
          <p:nvPr/>
        </p:nvSpPr>
        <p:spPr>
          <a:xfrm>
            <a:off x="5871755" y="4169455"/>
            <a:ext cx="2776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4E3DE186-5F17-4181-80CF-D08CD8B0CCF2}"/>
              </a:ext>
            </a:extLst>
          </p:cNvPr>
          <p:cNvSpPr txBox="1"/>
          <p:nvPr/>
        </p:nvSpPr>
        <p:spPr>
          <a:xfrm>
            <a:off x="3059592" y="1907319"/>
            <a:ext cx="140001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34">
            <a:extLst>
              <a:ext uri="{FF2B5EF4-FFF2-40B4-BE49-F238E27FC236}">
                <a16:creationId xmlns:a16="http://schemas.microsoft.com/office/drawing/2014/main" id="{975FB2F3-4529-E745-98EF-880D059EE574}"/>
              </a:ext>
            </a:extLst>
          </p:cNvPr>
          <p:cNvSpPr txBox="1"/>
          <p:nvPr/>
        </p:nvSpPr>
        <p:spPr>
          <a:xfrm>
            <a:off x="4986478" y="1917829"/>
            <a:ext cx="140001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7D05DEA-828E-4C42-B00D-1367E25AAB95}"/>
              </a:ext>
            </a:extLst>
          </p:cNvPr>
          <p:cNvSpPr txBox="1"/>
          <p:nvPr/>
        </p:nvSpPr>
        <p:spPr>
          <a:xfrm>
            <a:off x="634549" y="759995"/>
            <a:ext cx="27764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4A8549D-D3F2-DA4A-8B57-32A946827371}"/>
              </a:ext>
            </a:extLst>
          </p:cNvPr>
          <p:cNvSpPr txBox="1"/>
          <p:nvPr/>
        </p:nvSpPr>
        <p:spPr>
          <a:xfrm>
            <a:off x="2614166" y="759994"/>
            <a:ext cx="26962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2A7AC3E-F330-984E-9D98-8C2E1839CDFC}"/>
              </a:ext>
            </a:extLst>
          </p:cNvPr>
          <p:cNvSpPr txBox="1"/>
          <p:nvPr/>
        </p:nvSpPr>
        <p:spPr>
          <a:xfrm>
            <a:off x="4597502" y="759995"/>
            <a:ext cx="26962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41CD65B-7154-ED4E-9689-5E51666C85F7}"/>
              </a:ext>
            </a:extLst>
          </p:cNvPr>
          <p:cNvSpPr txBox="1"/>
          <p:nvPr/>
        </p:nvSpPr>
        <p:spPr>
          <a:xfrm>
            <a:off x="634549" y="2236055"/>
            <a:ext cx="27764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E685C5C-0C77-724D-8633-8E7FB55D7CC3}"/>
              </a:ext>
            </a:extLst>
          </p:cNvPr>
          <p:cNvSpPr txBox="1"/>
          <p:nvPr/>
        </p:nvSpPr>
        <p:spPr>
          <a:xfrm>
            <a:off x="2614166" y="2243020"/>
            <a:ext cx="263214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F9F7AE5-093E-0741-AB86-94A9F455FC16}"/>
              </a:ext>
            </a:extLst>
          </p:cNvPr>
          <p:cNvSpPr txBox="1"/>
          <p:nvPr/>
        </p:nvSpPr>
        <p:spPr>
          <a:xfrm>
            <a:off x="4597502" y="2236055"/>
            <a:ext cx="255198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38C5ED2-D67C-0C44-BC28-7285A526CC74}"/>
              </a:ext>
            </a:extLst>
          </p:cNvPr>
          <p:cNvSpPr txBox="1"/>
          <p:nvPr/>
        </p:nvSpPr>
        <p:spPr>
          <a:xfrm>
            <a:off x="634549" y="3708671"/>
            <a:ext cx="27764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69D727A-4F82-E249-89AE-5FE2B304DCDE}"/>
              </a:ext>
            </a:extLst>
          </p:cNvPr>
          <p:cNvSpPr txBox="1"/>
          <p:nvPr/>
        </p:nvSpPr>
        <p:spPr>
          <a:xfrm>
            <a:off x="2614166" y="3708670"/>
            <a:ext cx="27764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ADC13DF-BEB7-E14D-9F46-BC81DBCEED65}"/>
              </a:ext>
            </a:extLst>
          </p:cNvPr>
          <p:cNvSpPr txBox="1"/>
          <p:nvPr/>
        </p:nvSpPr>
        <p:spPr>
          <a:xfrm>
            <a:off x="4598552" y="3708669"/>
            <a:ext cx="227948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921C48C-935A-0C42-ACC6-9ED63D395BB6}"/>
              </a:ext>
            </a:extLst>
          </p:cNvPr>
          <p:cNvSpPr txBox="1"/>
          <p:nvPr/>
        </p:nvSpPr>
        <p:spPr>
          <a:xfrm>
            <a:off x="635036" y="5193822"/>
            <a:ext cx="23436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E07690D-EECE-3E4E-B46E-DC187604A291}"/>
              </a:ext>
            </a:extLst>
          </p:cNvPr>
          <p:cNvSpPr txBox="1"/>
          <p:nvPr/>
        </p:nvSpPr>
        <p:spPr>
          <a:xfrm>
            <a:off x="2614166" y="5198610"/>
            <a:ext cx="27764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2EAE57BE-1C06-C444-B9B2-BEBD3BF4D634}"/>
              </a:ext>
            </a:extLst>
          </p:cNvPr>
          <p:cNvSpPr txBox="1"/>
          <p:nvPr/>
        </p:nvSpPr>
        <p:spPr>
          <a:xfrm>
            <a:off x="4596357" y="5197027"/>
            <a:ext cx="263214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23ADEE6-3CE7-E442-822A-03662388554A}"/>
              </a:ext>
            </a:extLst>
          </p:cNvPr>
          <p:cNvSpPr txBox="1"/>
          <p:nvPr/>
        </p:nvSpPr>
        <p:spPr>
          <a:xfrm>
            <a:off x="634549" y="6671646"/>
            <a:ext cx="29848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61" name="テキスト ボックス 34">
            <a:extLst>
              <a:ext uri="{FF2B5EF4-FFF2-40B4-BE49-F238E27FC236}">
                <a16:creationId xmlns:a16="http://schemas.microsoft.com/office/drawing/2014/main" id="{845ACEBF-0E64-2048-A45A-72735C177D48}"/>
              </a:ext>
            </a:extLst>
          </p:cNvPr>
          <p:cNvSpPr txBox="1"/>
          <p:nvPr/>
        </p:nvSpPr>
        <p:spPr>
          <a:xfrm>
            <a:off x="1106547" y="3383282"/>
            <a:ext cx="140001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34">
            <a:extLst>
              <a:ext uri="{FF2B5EF4-FFF2-40B4-BE49-F238E27FC236}">
                <a16:creationId xmlns:a16="http://schemas.microsoft.com/office/drawing/2014/main" id="{8F12B5CA-FF14-2F44-A621-0200FB8E4C9F}"/>
              </a:ext>
            </a:extLst>
          </p:cNvPr>
          <p:cNvSpPr txBox="1"/>
          <p:nvPr/>
        </p:nvSpPr>
        <p:spPr>
          <a:xfrm>
            <a:off x="3059592" y="3388288"/>
            <a:ext cx="140001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34">
            <a:extLst>
              <a:ext uri="{FF2B5EF4-FFF2-40B4-BE49-F238E27FC236}">
                <a16:creationId xmlns:a16="http://schemas.microsoft.com/office/drawing/2014/main" id="{A2741EEA-3FB0-B145-9AF6-F3E71B12000B}"/>
              </a:ext>
            </a:extLst>
          </p:cNvPr>
          <p:cNvSpPr txBox="1"/>
          <p:nvPr/>
        </p:nvSpPr>
        <p:spPr>
          <a:xfrm>
            <a:off x="4986478" y="3383066"/>
            <a:ext cx="140001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34">
            <a:extLst>
              <a:ext uri="{FF2B5EF4-FFF2-40B4-BE49-F238E27FC236}">
                <a16:creationId xmlns:a16="http://schemas.microsoft.com/office/drawing/2014/main" id="{8C3DC2F9-D732-4642-BEFE-13745B2D86A9}"/>
              </a:ext>
            </a:extLst>
          </p:cNvPr>
          <p:cNvSpPr txBox="1"/>
          <p:nvPr/>
        </p:nvSpPr>
        <p:spPr>
          <a:xfrm>
            <a:off x="1106547" y="4846744"/>
            <a:ext cx="140001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34">
            <a:extLst>
              <a:ext uri="{FF2B5EF4-FFF2-40B4-BE49-F238E27FC236}">
                <a16:creationId xmlns:a16="http://schemas.microsoft.com/office/drawing/2014/main" id="{AD3327D2-ADD5-AB41-9481-28177B819936}"/>
              </a:ext>
            </a:extLst>
          </p:cNvPr>
          <p:cNvSpPr txBox="1"/>
          <p:nvPr/>
        </p:nvSpPr>
        <p:spPr>
          <a:xfrm>
            <a:off x="3059592" y="4845652"/>
            <a:ext cx="140001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34">
            <a:extLst>
              <a:ext uri="{FF2B5EF4-FFF2-40B4-BE49-F238E27FC236}">
                <a16:creationId xmlns:a16="http://schemas.microsoft.com/office/drawing/2014/main" id="{E9C33D66-C0A8-6243-8CDE-33B22EE7D508}"/>
              </a:ext>
            </a:extLst>
          </p:cNvPr>
          <p:cNvSpPr txBox="1"/>
          <p:nvPr/>
        </p:nvSpPr>
        <p:spPr>
          <a:xfrm>
            <a:off x="4986478" y="4845651"/>
            <a:ext cx="140001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34">
            <a:extLst>
              <a:ext uri="{FF2B5EF4-FFF2-40B4-BE49-F238E27FC236}">
                <a16:creationId xmlns:a16="http://schemas.microsoft.com/office/drawing/2014/main" id="{EB465BD8-1CCD-0142-AF0A-5ABC4E453284}"/>
              </a:ext>
            </a:extLst>
          </p:cNvPr>
          <p:cNvSpPr txBox="1"/>
          <p:nvPr/>
        </p:nvSpPr>
        <p:spPr>
          <a:xfrm>
            <a:off x="1106547" y="6358756"/>
            <a:ext cx="140001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34">
            <a:extLst>
              <a:ext uri="{FF2B5EF4-FFF2-40B4-BE49-F238E27FC236}">
                <a16:creationId xmlns:a16="http://schemas.microsoft.com/office/drawing/2014/main" id="{3EB87DC5-8E83-AF44-A621-1CC98AD4EB62}"/>
              </a:ext>
            </a:extLst>
          </p:cNvPr>
          <p:cNvSpPr txBox="1"/>
          <p:nvPr/>
        </p:nvSpPr>
        <p:spPr>
          <a:xfrm>
            <a:off x="3059592" y="6352989"/>
            <a:ext cx="140001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34">
            <a:extLst>
              <a:ext uri="{FF2B5EF4-FFF2-40B4-BE49-F238E27FC236}">
                <a16:creationId xmlns:a16="http://schemas.microsoft.com/office/drawing/2014/main" id="{F9E6EA70-9C7E-014E-BA2C-A3BBC4A9B27D}"/>
              </a:ext>
            </a:extLst>
          </p:cNvPr>
          <p:cNvSpPr txBox="1"/>
          <p:nvPr/>
        </p:nvSpPr>
        <p:spPr>
          <a:xfrm>
            <a:off x="4986478" y="6352988"/>
            <a:ext cx="140001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34">
            <a:extLst>
              <a:ext uri="{FF2B5EF4-FFF2-40B4-BE49-F238E27FC236}">
                <a16:creationId xmlns:a16="http://schemas.microsoft.com/office/drawing/2014/main" id="{4E5DF29D-1550-7D4E-9F26-1D459B12CE87}"/>
              </a:ext>
            </a:extLst>
          </p:cNvPr>
          <p:cNvSpPr txBox="1"/>
          <p:nvPr/>
        </p:nvSpPr>
        <p:spPr>
          <a:xfrm>
            <a:off x="1106547" y="7803364"/>
            <a:ext cx="140001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Text Box 30">
            <a:extLst>
              <a:ext uri="{FF2B5EF4-FFF2-40B4-BE49-F238E27FC236}">
                <a16:creationId xmlns:a16="http://schemas.microsoft.com/office/drawing/2014/main" id="{1A1FBC9E-FBAF-0146-9507-F317A9D433C7}"/>
              </a:ext>
            </a:extLst>
          </p:cNvPr>
          <p:cNvSpPr txBox="1"/>
          <p:nvPr/>
        </p:nvSpPr>
        <p:spPr>
          <a:xfrm rot="16200000">
            <a:off x="-841297" y="4105867"/>
            <a:ext cx="2631440" cy="372379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132080" tIns="66040" rIns="132080" bIns="6604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JP" sz="1200" dirty="0"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Relative expression level</a:t>
            </a:r>
            <a:endParaRPr lang="en-JP" sz="1400" dirty="0"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5856118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10</TotalTime>
  <Words>58</Words>
  <Application>Microsoft Office PowerPoint</Application>
  <PresentationFormat>A4 210 x 297 mm</PresentationFormat>
  <Paragraphs>4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in Neang</dc:creator>
  <cp:lastModifiedBy>三屋 史朗</cp:lastModifiedBy>
  <cp:revision>90</cp:revision>
  <cp:lastPrinted>2020-08-12T07:18:28Z</cp:lastPrinted>
  <dcterms:created xsi:type="dcterms:W3CDTF">2020-05-19T13:06:08Z</dcterms:created>
  <dcterms:modified xsi:type="dcterms:W3CDTF">2020-08-13T07:28:48Z</dcterms:modified>
</cp:coreProperties>
</file>